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42" d="100"/>
          <a:sy n="142" d="100"/>
        </p:scale>
        <p:origin x="-992" y="7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ijuan:Google%20Drev:S%20aurues%20infection:PNAS%20manuscript:COG%20catogori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99675744667073"/>
          <c:y val="0.0502564102564103"/>
          <c:w val="0.846719854498536"/>
          <c:h val="0.34522401587494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D$1</c:f>
              <c:strCache>
                <c:ptCount val="1"/>
                <c:pt idx="0">
                  <c:v>Proteins </c:v>
                </c:pt>
              </c:strCache>
            </c:strRef>
          </c:tx>
          <c:invertIfNegative val="0"/>
          <c:dLbls>
            <c:delete val="1"/>
          </c:dLbls>
          <c:cat>
            <c:multiLvlStrRef>
              <c:f>Sheet2!$A$2:$C$23</c:f>
              <c:multiLvlStrCache>
                <c:ptCount val="22"/>
                <c:lvl>
                  <c:pt idx="0">
                    <c:v>Cell cycle control, cell division, chromosome partitioning</c:v>
                  </c:pt>
                  <c:pt idx="1">
                    <c:v>Cell wall/membrane/envelope biogenesis</c:v>
                  </c:pt>
                  <c:pt idx="2">
                    <c:v>Cell motility</c:v>
                  </c:pt>
                  <c:pt idx="3">
                    <c:v>Posttranslational modification, protein turnover, chaperones</c:v>
                  </c:pt>
                  <c:pt idx="4">
                    <c:v>Signal transduction mechanisms</c:v>
                  </c:pt>
                  <c:pt idx="5">
                    <c:v>Intracellular trafficking, secretion, and vesicular transport</c:v>
                  </c:pt>
                  <c:pt idx="6">
                    <c:v>Defense mechanisms</c:v>
                  </c:pt>
                  <c:pt idx="7">
                    <c:v>Extracellular structures</c:v>
                  </c:pt>
                  <c:pt idx="8">
                    <c:v>Chromatin structure and dynamics</c:v>
                  </c:pt>
                  <c:pt idx="9">
                    <c:v>Translation, ribosomal structure and biogenesis</c:v>
                  </c:pt>
                  <c:pt idx="10">
                    <c:v>Transcription</c:v>
                  </c:pt>
                  <c:pt idx="11">
                    <c:v>Replication, recombination and repair</c:v>
                  </c:pt>
                  <c:pt idx="12">
                    <c:v>Energy production and conversion</c:v>
                  </c:pt>
                  <c:pt idx="13">
                    <c:v>Amino acid transport and metabolism</c:v>
                  </c:pt>
                  <c:pt idx="14">
                    <c:v>Nucleotide transport and metabolism</c:v>
                  </c:pt>
                  <c:pt idx="15">
                    <c:v>Carbohydrate transport and metabolism</c:v>
                  </c:pt>
                  <c:pt idx="16">
                    <c:v>Coenzyme transport and metabolism</c:v>
                  </c:pt>
                  <c:pt idx="17">
                    <c:v>Lipid transport and metabolism</c:v>
                  </c:pt>
                  <c:pt idx="18">
                    <c:v>Inorganic ion transport and metabolism</c:v>
                  </c:pt>
                  <c:pt idx="19">
                    <c:v>Secondary metabolites biosynthesis, transport and catabolism</c:v>
                  </c:pt>
                  <c:pt idx="20">
                    <c:v>General function prediction only</c:v>
                  </c:pt>
                  <c:pt idx="21">
                    <c:v>Function unknown</c:v>
                  </c:pt>
                </c:lvl>
                <c:lvl>
                  <c:pt idx="0">
                    <c:v>D</c:v>
                  </c:pt>
                  <c:pt idx="1">
                    <c:v>M</c:v>
                  </c:pt>
                  <c:pt idx="2">
                    <c:v>N</c:v>
                  </c:pt>
                  <c:pt idx="3">
                    <c:v>O</c:v>
                  </c:pt>
                  <c:pt idx="4">
                    <c:v>T</c:v>
                  </c:pt>
                  <c:pt idx="5">
                    <c:v>U</c:v>
                  </c:pt>
                  <c:pt idx="6">
                    <c:v>V</c:v>
                  </c:pt>
                  <c:pt idx="7">
                    <c:v>W</c:v>
                  </c:pt>
                  <c:pt idx="8">
                    <c:v>B</c:v>
                  </c:pt>
                  <c:pt idx="9">
                    <c:v>J</c:v>
                  </c:pt>
                  <c:pt idx="10">
                    <c:v>K</c:v>
                  </c:pt>
                  <c:pt idx="11">
                    <c:v>L</c:v>
                  </c:pt>
                  <c:pt idx="12">
                    <c:v>C</c:v>
                  </c:pt>
                  <c:pt idx="13">
                    <c:v>E</c:v>
                  </c:pt>
                  <c:pt idx="14">
                    <c:v>F</c:v>
                  </c:pt>
                  <c:pt idx="15">
                    <c:v>G</c:v>
                  </c:pt>
                  <c:pt idx="16">
                    <c:v>H</c:v>
                  </c:pt>
                  <c:pt idx="17">
                    <c:v>I</c:v>
                  </c:pt>
                  <c:pt idx="18">
                    <c:v>P</c:v>
                  </c:pt>
                  <c:pt idx="19">
                    <c:v>Q</c:v>
                  </c:pt>
                  <c:pt idx="20">
                    <c:v>R</c:v>
                  </c:pt>
                  <c:pt idx="21">
                    <c:v>S</c:v>
                  </c:pt>
                </c:lvl>
                <c:lvl>
                  <c:pt idx="0">
                    <c:v>Celluar process and signaling</c:v>
                  </c:pt>
                  <c:pt idx="8">
                    <c:v>Information storage and processing</c:v>
                  </c:pt>
                  <c:pt idx="12">
                    <c:v>Metabolism</c:v>
                  </c:pt>
                  <c:pt idx="20">
                    <c:v>Poorly characterized</c:v>
                  </c:pt>
                </c:lvl>
              </c:multiLvlStrCache>
            </c:multiLvlStrRef>
          </c:cat>
          <c:val>
            <c:numRef>
              <c:f>Sheet2!$D$2:$D$23</c:f>
              <c:numCache>
                <c:formatCode>General</c:formatCode>
                <c:ptCount val="22"/>
                <c:pt idx="0">
                  <c:v>38.0</c:v>
                </c:pt>
                <c:pt idx="1">
                  <c:v>125.0</c:v>
                </c:pt>
                <c:pt idx="2">
                  <c:v>12.0</c:v>
                </c:pt>
                <c:pt idx="3">
                  <c:v>77.0</c:v>
                </c:pt>
                <c:pt idx="4">
                  <c:v>74.0</c:v>
                </c:pt>
                <c:pt idx="5">
                  <c:v>29.0</c:v>
                </c:pt>
                <c:pt idx="6">
                  <c:v>48.0</c:v>
                </c:pt>
                <c:pt idx="7">
                  <c:v>1.0</c:v>
                </c:pt>
                <c:pt idx="8">
                  <c:v>1.0</c:v>
                </c:pt>
                <c:pt idx="9">
                  <c:v>155.0</c:v>
                </c:pt>
                <c:pt idx="10">
                  <c:v>180.0</c:v>
                </c:pt>
                <c:pt idx="11">
                  <c:v>140.0</c:v>
                </c:pt>
                <c:pt idx="12">
                  <c:v>117.0</c:v>
                </c:pt>
                <c:pt idx="13">
                  <c:v>264.0</c:v>
                </c:pt>
                <c:pt idx="14">
                  <c:v>73.0</c:v>
                </c:pt>
                <c:pt idx="15">
                  <c:v>184.0</c:v>
                </c:pt>
                <c:pt idx="16">
                  <c:v>102.0</c:v>
                </c:pt>
                <c:pt idx="17">
                  <c:v>69.0</c:v>
                </c:pt>
                <c:pt idx="18">
                  <c:v>188.0</c:v>
                </c:pt>
                <c:pt idx="19">
                  <c:v>41.0</c:v>
                </c:pt>
                <c:pt idx="20">
                  <c:v>332.0</c:v>
                </c:pt>
                <c:pt idx="21">
                  <c:v>221.0</c:v>
                </c:pt>
              </c:numCache>
            </c:numRef>
          </c:val>
        </c:ser>
        <c:ser>
          <c:idx val="1"/>
          <c:order val="1"/>
          <c:tx>
            <c:strRef>
              <c:f>Sheet2!$E$1</c:f>
              <c:strCache>
                <c:ptCount val="1"/>
                <c:pt idx="0">
                  <c:v>Up</c:v>
                </c:pt>
              </c:strCache>
            </c:strRef>
          </c:tx>
          <c:invertIfNegative val="0"/>
          <c:dLbls>
            <c:delete val="1"/>
          </c:dLbls>
          <c:cat>
            <c:multiLvlStrRef>
              <c:f>Sheet2!$A$2:$C$23</c:f>
              <c:multiLvlStrCache>
                <c:ptCount val="22"/>
                <c:lvl>
                  <c:pt idx="0">
                    <c:v>Cell cycle control, cell division, chromosome partitioning</c:v>
                  </c:pt>
                  <c:pt idx="1">
                    <c:v>Cell wall/membrane/envelope biogenesis</c:v>
                  </c:pt>
                  <c:pt idx="2">
                    <c:v>Cell motility</c:v>
                  </c:pt>
                  <c:pt idx="3">
                    <c:v>Posttranslational modification, protein turnover, chaperones</c:v>
                  </c:pt>
                  <c:pt idx="4">
                    <c:v>Signal transduction mechanisms</c:v>
                  </c:pt>
                  <c:pt idx="5">
                    <c:v>Intracellular trafficking, secretion, and vesicular transport</c:v>
                  </c:pt>
                  <c:pt idx="6">
                    <c:v>Defense mechanisms</c:v>
                  </c:pt>
                  <c:pt idx="7">
                    <c:v>Extracellular structures</c:v>
                  </c:pt>
                  <c:pt idx="8">
                    <c:v>Chromatin structure and dynamics</c:v>
                  </c:pt>
                  <c:pt idx="9">
                    <c:v>Translation, ribosomal structure and biogenesis</c:v>
                  </c:pt>
                  <c:pt idx="10">
                    <c:v>Transcription</c:v>
                  </c:pt>
                  <c:pt idx="11">
                    <c:v>Replication, recombination and repair</c:v>
                  </c:pt>
                  <c:pt idx="12">
                    <c:v>Energy production and conversion</c:v>
                  </c:pt>
                  <c:pt idx="13">
                    <c:v>Amino acid transport and metabolism</c:v>
                  </c:pt>
                  <c:pt idx="14">
                    <c:v>Nucleotide transport and metabolism</c:v>
                  </c:pt>
                  <c:pt idx="15">
                    <c:v>Carbohydrate transport and metabolism</c:v>
                  </c:pt>
                  <c:pt idx="16">
                    <c:v>Coenzyme transport and metabolism</c:v>
                  </c:pt>
                  <c:pt idx="17">
                    <c:v>Lipid transport and metabolism</c:v>
                  </c:pt>
                  <c:pt idx="18">
                    <c:v>Inorganic ion transport and metabolism</c:v>
                  </c:pt>
                  <c:pt idx="19">
                    <c:v>Secondary metabolites biosynthesis, transport and catabolism</c:v>
                  </c:pt>
                  <c:pt idx="20">
                    <c:v>General function prediction only</c:v>
                  </c:pt>
                  <c:pt idx="21">
                    <c:v>Function unknown</c:v>
                  </c:pt>
                </c:lvl>
                <c:lvl>
                  <c:pt idx="0">
                    <c:v>D</c:v>
                  </c:pt>
                  <c:pt idx="1">
                    <c:v>M</c:v>
                  </c:pt>
                  <c:pt idx="2">
                    <c:v>N</c:v>
                  </c:pt>
                  <c:pt idx="3">
                    <c:v>O</c:v>
                  </c:pt>
                  <c:pt idx="4">
                    <c:v>T</c:v>
                  </c:pt>
                  <c:pt idx="5">
                    <c:v>U</c:v>
                  </c:pt>
                  <c:pt idx="6">
                    <c:v>V</c:v>
                  </c:pt>
                  <c:pt idx="7">
                    <c:v>W</c:v>
                  </c:pt>
                  <c:pt idx="8">
                    <c:v>B</c:v>
                  </c:pt>
                  <c:pt idx="9">
                    <c:v>J</c:v>
                  </c:pt>
                  <c:pt idx="10">
                    <c:v>K</c:v>
                  </c:pt>
                  <c:pt idx="11">
                    <c:v>L</c:v>
                  </c:pt>
                  <c:pt idx="12">
                    <c:v>C</c:v>
                  </c:pt>
                  <c:pt idx="13">
                    <c:v>E</c:v>
                  </c:pt>
                  <c:pt idx="14">
                    <c:v>F</c:v>
                  </c:pt>
                  <c:pt idx="15">
                    <c:v>G</c:v>
                  </c:pt>
                  <c:pt idx="16">
                    <c:v>H</c:v>
                  </c:pt>
                  <c:pt idx="17">
                    <c:v>I</c:v>
                  </c:pt>
                  <c:pt idx="18">
                    <c:v>P</c:v>
                  </c:pt>
                  <c:pt idx="19">
                    <c:v>Q</c:v>
                  </c:pt>
                  <c:pt idx="20">
                    <c:v>R</c:v>
                  </c:pt>
                  <c:pt idx="21">
                    <c:v>S</c:v>
                  </c:pt>
                </c:lvl>
                <c:lvl>
                  <c:pt idx="0">
                    <c:v>Celluar process and signaling</c:v>
                  </c:pt>
                  <c:pt idx="8">
                    <c:v>Information storage and processing</c:v>
                  </c:pt>
                  <c:pt idx="12">
                    <c:v>Metabolism</c:v>
                  </c:pt>
                  <c:pt idx="20">
                    <c:v>Poorly characterized</c:v>
                  </c:pt>
                </c:lvl>
              </c:multiLvlStrCache>
            </c:multiLvlStrRef>
          </c:cat>
          <c:val>
            <c:numRef>
              <c:f>Sheet2!$E$2:$E$23</c:f>
              <c:numCache>
                <c:formatCode>General</c:formatCode>
                <c:ptCount val="22"/>
                <c:pt idx="0">
                  <c:v>4.0</c:v>
                </c:pt>
                <c:pt idx="1">
                  <c:v>16.0</c:v>
                </c:pt>
                <c:pt idx="2">
                  <c:v>0.0</c:v>
                </c:pt>
                <c:pt idx="3">
                  <c:v>15.0</c:v>
                </c:pt>
                <c:pt idx="4">
                  <c:v>12.0</c:v>
                </c:pt>
                <c:pt idx="5">
                  <c:v>3.0</c:v>
                </c:pt>
                <c:pt idx="6">
                  <c:v>5.0</c:v>
                </c:pt>
                <c:pt idx="7">
                  <c:v>0.0</c:v>
                </c:pt>
                <c:pt idx="8">
                  <c:v>1.0</c:v>
                </c:pt>
                <c:pt idx="9">
                  <c:v>8.0</c:v>
                </c:pt>
                <c:pt idx="10">
                  <c:v>23.0</c:v>
                </c:pt>
                <c:pt idx="11">
                  <c:v>10.0</c:v>
                </c:pt>
                <c:pt idx="12">
                  <c:v>12.0</c:v>
                </c:pt>
                <c:pt idx="13">
                  <c:v>44.0</c:v>
                </c:pt>
                <c:pt idx="14">
                  <c:v>7.0</c:v>
                </c:pt>
                <c:pt idx="15">
                  <c:v>42.0</c:v>
                </c:pt>
                <c:pt idx="16">
                  <c:v>4.0</c:v>
                </c:pt>
                <c:pt idx="17">
                  <c:v>7.0</c:v>
                </c:pt>
                <c:pt idx="18">
                  <c:v>28.0</c:v>
                </c:pt>
                <c:pt idx="19">
                  <c:v>10.0</c:v>
                </c:pt>
                <c:pt idx="20">
                  <c:v>29.0</c:v>
                </c:pt>
                <c:pt idx="21">
                  <c:v>20.0</c:v>
                </c:pt>
              </c:numCache>
            </c:numRef>
          </c:val>
        </c:ser>
        <c:ser>
          <c:idx val="2"/>
          <c:order val="2"/>
          <c:tx>
            <c:strRef>
              <c:f>Sheet2!$F$1</c:f>
              <c:strCache>
                <c:ptCount val="1"/>
                <c:pt idx="0">
                  <c:v>Down</c:v>
                </c:pt>
              </c:strCache>
            </c:strRef>
          </c:tx>
          <c:invertIfNegative val="0"/>
          <c:dLbls>
            <c:delete val="1"/>
          </c:dLbls>
          <c:cat>
            <c:multiLvlStrRef>
              <c:f>Sheet2!$A$2:$C$23</c:f>
              <c:multiLvlStrCache>
                <c:ptCount val="22"/>
                <c:lvl>
                  <c:pt idx="0">
                    <c:v>Cell cycle control, cell division, chromosome partitioning</c:v>
                  </c:pt>
                  <c:pt idx="1">
                    <c:v>Cell wall/membrane/envelope biogenesis</c:v>
                  </c:pt>
                  <c:pt idx="2">
                    <c:v>Cell motility</c:v>
                  </c:pt>
                  <c:pt idx="3">
                    <c:v>Posttranslational modification, protein turnover, chaperones</c:v>
                  </c:pt>
                  <c:pt idx="4">
                    <c:v>Signal transduction mechanisms</c:v>
                  </c:pt>
                  <c:pt idx="5">
                    <c:v>Intracellular trafficking, secretion, and vesicular transport</c:v>
                  </c:pt>
                  <c:pt idx="6">
                    <c:v>Defense mechanisms</c:v>
                  </c:pt>
                  <c:pt idx="7">
                    <c:v>Extracellular structures</c:v>
                  </c:pt>
                  <c:pt idx="8">
                    <c:v>Chromatin structure and dynamics</c:v>
                  </c:pt>
                  <c:pt idx="9">
                    <c:v>Translation, ribosomal structure and biogenesis</c:v>
                  </c:pt>
                  <c:pt idx="10">
                    <c:v>Transcription</c:v>
                  </c:pt>
                  <c:pt idx="11">
                    <c:v>Replication, recombination and repair</c:v>
                  </c:pt>
                  <c:pt idx="12">
                    <c:v>Energy production and conversion</c:v>
                  </c:pt>
                  <c:pt idx="13">
                    <c:v>Amino acid transport and metabolism</c:v>
                  </c:pt>
                  <c:pt idx="14">
                    <c:v>Nucleotide transport and metabolism</c:v>
                  </c:pt>
                  <c:pt idx="15">
                    <c:v>Carbohydrate transport and metabolism</c:v>
                  </c:pt>
                  <c:pt idx="16">
                    <c:v>Coenzyme transport and metabolism</c:v>
                  </c:pt>
                  <c:pt idx="17">
                    <c:v>Lipid transport and metabolism</c:v>
                  </c:pt>
                  <c:pt idx="18">
                    <c:v>Inorganic ion transport and metabolism</c:v>
                  </c:pt>
                  <c:pt idx="19">
                    <c:v>Secondary metabolites biosynthesis, transport and catabolism</c:v>
                  </c:pt>
                  <c:pt idx="20">
                    <c:v>General function prediction only</c:v>
                  </c:pt>
                  <c:pt idx="21">
                    <c:v>Function unknown</c:v>
                  </c:pt>
                </c:lvl>
                <c:lvl>
                  <c:pt idx="0">
                    <c:v>D</c:v>
                  </c:pt>
                  <c:pt idx="1">
                    <c:v>M</c:v>
                  </c:pt>
                  <c:pt idx="2">
                    <c:v>N</c:v>
                  </c:pt>
                  <c:pt idx="3">
                    <c:v>O</c:v>
                  </c:pt>
                  <c:pt idx="4">
                    <c:v>T</c:v>
                  </c:pt>
                  <c:pt idx="5">
                    <c:v>U</c:v>
                  </c:pt>
                  <c:pt idx="6">
                    <c:v>V</c:v>
                  </c:pt>
                  <c:pt idx="7">
                    <c:v>W</c:v>
                  </c:pt>
                  <c:pt idx="8">
                    <c:v>B</c:v>
                  </c:pt>
                  <c:pt idx="9">
                    <c:v>J</c:v>
                  </c:pt>
                  <c:pt idx="10">
                    <c:v>K</c:v>
                  </c:pt>
                  <c:pt idx="11">
                    <c:v>L</c:v>
                  </c:pt>
                  <c:pt idx="12">
                    <c:v>C</c:v>
                  </c:pt>
                  <c:pt idx="13">
                    <c:v>E</c:v>
                  </c:pt>
                  <c:pt idx="14">
                    <c:v>F</c:v>
                  </c:pt>
                  <c:pt idx="15">
                    <c:v>G</c:v>
                  </c:pt>
                  <c:pt idx="16">
                    <c:v>H</c:v>
                  </c:pt>
                  <c:pt idx="17">
                    <c:v>I</c:v>
                  </c:pt>
                  <c:pt idx="18">
                    <c:v>P</c:v>
                  </c:pt>
                  <c:pt idx="19">
                    <c:v>Q</c:v>
                  </c:pt>
                  <c:pt idx="20">
                    <c:v>R</c:v>
                  </c:pt>
                  <c:pt idx="21">
                    <c:v>S</c:v>
                  </c:pt>
                </c:lvl>
                <c:lvl>
                  <c:pt idx="0">
                    <c:v>Celluar process and signaling</c:v>
                  </c:pt>
                  <c:pt idx="8">
                    <c:v>Information storage and processing</c:v>
                  </c:pt>
                  <c:pt idx="12">
                    <c:v>Metabolism</c:v>
                  </c:pt>
                  <c:pt idx="20">
                    <c:v>Poorly characterized</c:v>
                  </c:pt>
                </c:lvl>
              </c:multiLvlStrCache>
            </c:multiLvlStrRef>
          </c:cat>
          <c:val>
            <c:numRef>
              <c:f>Sheet2!$F$2:$F$23</c:f>
              <c:numCache>
                <c:formatCode>General</c:formatCode>
                <c:ptCount val="22"/>
                <c:pt idx="0">
                  <c:v>2.0</c:v>
                </c:pt>
                <c:pt idx="1">
                  <c:v>3.0</c:v>
                </c:pt>
                <c:pt idx="2">
                  <c:v>1.0</c:v>
                </c:pt>
                <c:pt idx="3">
                  <c:v>1.0</c:v>
                </c:pt>
                <c:pt idx="4">
                  <c:v>2.0</c:v>
                </c:pt>
                <c:pt idx="5">
                  <c:v>1.0</c:v>
                </c:pt>
                <c:pt idx="6">
                  <c:v>4.0</c:v>
                </c:pt>
                <c:pt idx="7">
                  <c:v>0.0</c:v>
                </c:pt>
                <c:pt idx="8">
                  <c:v>0.0</c:v>
                </c:pt>
                <c:pt idx="9">
                  <c:v>7.0</c:v>
                </c:pt>
                <c:pt idx="10">
                  <c:v>5.0</c:v>
                </c:pt>
                <c:pt idx="11">
                  <c:v>7.0</c:v>
                </c:pt>
                <c:pt idx="12">
                  <c:v>1.0</c:v>
                </c:pt>
                <c:pt idx="13">
                  <c:v>15.0</c:v>
                </c:pt>
                <c:pt idx="14">
                  <c:v>4.0</c:v>
                </c:pt>
                <c:pt idx="15">
                  <c:v>2.0</c:v>
                </c:pt>
                <c:pt idx="16">
                  <c:v>3.0</c:v>
                </c:pt>
                <c:pt idx="17">
                  <c:v>3.0</c:v>
                </c:pt>
                <c:pt idx="18">
                  <c:v>8.0</c:v>
                </c:pt>
                <c:pt idx="19">
                  <c:v>2.0</c:v>
                </c:pt>
                <c:pt idx="20">
                  <c:v>13.0</c:v>
                </c:pt>
                <c:pt idx="21">
                  <c:v>9.0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2101273576"/>
        <c:axId val="2101265736"/>
      </c:barChart>
      <c:catAx>
        <c:axId val="21012735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01265736"/>
        <c:crosses val="autoZero"/>
        <c:auto val="1"/>
        <c:lblAlgn val="ctr"/>
        <c:lblOffset val="100"/>
        <c:noMultiLvlLbl val="0"/>
      </c:catAx>
      <c:valAx>
        <c:axId val="21012657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700" b="0"/>
                </a:pPr>
                <a:r>
                  <a:rPr lang="da-DK" sz="700" b="0" dirty="0" err="1" smtClean="0"/>
                  <a:t>Number</a:t>
                </a:r>
                <a:r>
                  <a:rPr lang="da-DK" sz="700" b="0" dirty="0" smtClean="0"/>
                  <a:t> of genes</a:t>
                </a:r>
                <a:endParaRPr lang="da-DK" sz="700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12735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993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640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834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467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687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319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107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79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861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732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022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0640E-8D0F-2B4F-B42E-42B22C291CDA}" type="datetimeFigureOut">
              <a:rPr lang="en-US" smtClean="0"/>
              <a:t>3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378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52527" y="823173"/>
            <a:ext cx="519714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 err="1"/>
              <a:t>Figure</a:t>
            </a:r>
            <a:r>
              <a:rPr lang="da-DK" sz="1200" dirty="0"/>
              <a:t> </a:t>
            </a:r>
            <a:r>
              <a:rPr lang="da-DK" sz="1200" dirty="0" smtClean="0"/>
              <a:t>S1 </a:t>
            </a:r>
            <a:r>
              <a:rPr lang="en-US" sz="1200" dirty="0"/>
              <a:t>Clusters of Orthologous Groups (COG) classification distribution of the protein-coding </a:t>
            </a:r>
            <a:r>
              <a:rPr lang="en-US" sz="1200" dirty="0" smtClean="0"/>
              <a:t>genes </a:t>
            </a:r>
            <a:r>
              <a:rPr lang="en-US" sz="1200" dirty="0"/>
              <a:t>and the number of up- and down- regulated genes </a:t>
            </a:r>
            <a:r>
              <a:rPr lang="en-US" sz="1200" i="1" dirty="0" smtClean="0"/>
              <a:t>in situ</a:t>
            </a:r>
            <a:r>
              <a:rPr lang="en-US" sz="1200" dirty="0" smtClean="0"/>
              <a:t> in </a:t>
            </a:r>
            <a:r>
              <a:rPr lang="en-US" sz="1200" dirty="0"/>
              <a:t>each category. 81.34 % of the protein-coding sequences are classified in at least one COG group (2084 of </a:t>
            </a:r>
            <a:r>
              <a:rPr lang="en-US" sz="1200" dirty="0" smtClean="0"/>
              <a:t>2562 </a:t>
            </a:r>
            <a:r>
              <a:rPr lang="en-US" sz="1200" dirty="0"/>
              <a:t>protein coding sequences)</a:t>
            </a:r>
            <a:r>
              <a:rPr lang="en-US" sz="1200" dirty="0" smtClean="0"/>
              <a:t>.Blue: protein-coding genes; red: </a:t>
            </a:r>
            <a:r>
              <a:rPr lang="en-US" sz="1200" dirty="0" err="1" smtClean="0"/>
              <a:t>upregulated</a:t>
            </a:r>
            <a:r>
              <a:rPr lang="en-US" sz="1200" dirty="0" smtClean="0"/>
              <a:t> genes; green: </a:t>
            </a:r>
            <a:r>
              <a:rPr lang="en-US" sz="1200" dirty="0" err="1" smtClean="0"/>
              <a:t>downregulated</a:t>
            </a:r>
            <a:r>
              <a:rPr lang="en-US" sz="1200" dirty="0" smtClean="0"/>
              <a:t> genes.</a:t>
            </a:r>
            <a:endParaRPr lang="da-DK" sz="1200" dirty="0"/>
          </a:p>
          <a:p>
            <a:endParaRPr lang="en-US" sz="1200" dirty="0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396067"/>
              </p:ext>
            </p:extLst>
          </p:nvPr>
        </p:nvGraphicFramePr>
        <p:xfrm>
          <a:off x="587917" y="1693385"/>
          <a:ext cx="5744547" cy="7643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58492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79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lbo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juan Xu</dc:creator>
  <cp:lastModifiedBy>Yijuan Xu</cp:lastModifiedBy>
  <cp:revision>21</cp:revision>
  <dcterms:created xsi:type="dcterms:W3CDTF">2014-07-29T14:16:37Z</dcterms:created>
  <dcterms:modified xsi:type="dcterms:W3CDTF">2015-12-31T14:47:22Z</dcterms:modified>
</cp:coreProperties>
</file>